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7" r:id="rId2"/>
    <p:sldId id="269" r:id="rId3"/>
    <p:sldId id="256" r:id="rId4"/>
    <p:sldId id="274" r:id="rId5"/>
    <p:sldId id="273" r:id="rId6"/>
    <p:sldId id="270" r:id="rId7"/>
  </p:sldIdLst>
  <p:sldSz cx="5292725" cy="8459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139" autoAdjust="0"/>
    <p:restoredTop sz="94660"/>
  </p:normalViewPr>
  <p:slideViewPr>
    <p:cSldViewPr snapToGrid="0">
      <p:cViewPr varScale="1">
        <p:scale>
          <a:sx n="93" d="100"/>
          <a:sy n="93" d="100"/>
        </p:scale>
        <p:origin x="33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6955" y="1384507"/>
            <a:ext cx="4498816" cy="2945260"/>
          </a:xfrm>
        </p:spPr>
        <p:txBody>
          <a:bodyPr anchor="b"/>
          <a:lstStyle>
            <a:lvl1pPr algn="ctr">
              <a:defRPr sz="347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1591" y="4443348"/>
            <a:ext cx="3969544" cy="2042490"/>
          </a:xfrm>
        </p:spPr>
        <p:txBody>
          <a:bodyPr/>
          <a:lstStyle>
            <a:lvl1pPr marL="0" indent="0" algn="ctr">
              <a:buNone/>
              <a:defRPr sz="1389"/>
            </a:lvl1pPr>
            <a:lvl2pPr marL="264627" indent="0" algn="ctr">
              <a:buNone/>
              <a:defRPr sz="1158"/>
            </a:lvl2pPr>
            <a:lvl3pPr marL="529255" indent="0" algn="ctr">
              <a:buNone/>
              <a:defRPr sz="1042"/>
            </a:lvl3pPr>
            <a:lvl4pPr marL="793882" indent="0" algn="ctr">
              <a:buNone/>
              <a:defRPr sz="926"/>
            </a:lvl4pPr>
            <a:lvl5pPr marL="1058509" indent="0" algn="ctr">
              <a:buNone/>
              <a:defRPr sz="926"/>
            </a:lvl5pPr>
            <a:lvl6pPr marL="1323137" indent="0" algn="ctr">
              <a:buNone/>
              <a:defRPr sz="926"/>
            </a:lvl6pPr>
            <a:lvl7pPr marL="1587764" indent="0" algn="ctr">
              <a:buNone/>
              <a:defRPr sz="926"/>
            </a:lvl7pPr>
            <a:lvl8pPr marL="1852392" indent="0" algn="ctr">
              <a:buNone/>
              <a:defRPr sz="926"/>
            </a:lvl8pPr>
            <a:lvl9pPr marL="2117019" indent="0" algn="ctr">
              <a:buNone/>
              <a:defRPr sz="92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63152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43167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87607" y="450406"/>
            <a:ext cx="1141244" cy="71692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3875" y="450406"/>
            <a:ext cx="3357572" cy="71692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2969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00257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119" y="2109075"/>
            <a:ext cx="4564975" cy="3519036"/>
          </a:xfrm>
        </p:spPr>
        <p:txBody>
          <a:bodyPr anchor="b"/>
          <a:lstStyle>
            <a:lvl1pPr>
              <a:defRPr sz="347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1119" y="5661402"/>
            <a:ext cx="4564975" cy="1850578"/>
          </a:xfrm>
        </p:spPr>
        <p:txBody>
          <a:bodyPr/>
          <a:lstStyle>
            <a:lvl1pPr marL="0" indent="0">
              <a:buNone/>
              <a:defRPr sz="1389">
                <a:solidFill>
                  <a:schemeClr val="tx1"/>
                </a:solidFill>
              </a:defRPr>
            </a:lvl1pPr>
            <a:lvl2pPr marL="264627" indent="0">
              <a:buNone/>
              <a:defRPr sz="1158">
                <a:solidFill>
                  <a:schemeClr val="tx1">
                    <a:tint val="75000"/>
                  </a:schemeClr>
                </a:solidFill>
              </a:defRPr>
            </a:lvl2pPr>
            <a:lvl3pPr marL="529255" indent="0">
              <a:buNone/>
              <a:defRPr sz="1042">
                <a:solidFill>
                  <a:schemeClr val="tx1">
                    <a:tint val="75000"/>
                  </a:schemeClr>
                </a:solidFill>
              </a:defRPr>
            </a:lvl3pPr>
            <a:lvl4pPr marL="793882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4pPr>
            <a:lvl5pPr marL="1058509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5pPr>
            <a:lvl6pPr marL="1323137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6pPr>
            <a:lvl7pPr marL="1587764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7pPr>
            <a:lvl8pPr marL="1852392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8pPr>
            <a:lvl9pPr marL="2117019" indent="0">
              <a:buNone/>
              <a:defRPr sz="92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8598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3875" y="2252027"/>
            <a:ext cx="2249408" cy="536765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79442" y="2252027"/>
            <a:ext cx="2249408" cy="536765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002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564" y="450407"/>
            <a:ext cx="4564975" cy="16351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4565" y="2073824"/>
            <a:ext cx="2239070" cy="1016349"/>
          </a:xfrm>
        </p:spPr>
        <p:txBody>
          <a:bodyPr anchor="b"/>
          <a:lstStyle>
            <a:lvl1pPr marL="0" indent="0">
              <a:buNone/>
              <a:defRPr sz="1389" b="1"/>
            </a:lvl1pPr>
            <a:lvl2pPr marL="264627" indent="0">
              <a:buNone/>
              <a:defRPr sz="1158" b="1"/>
            </a:lvl2pPr>
            <a:lvl3pPr marL="529255" indent="0">
              <a:buNone/>
              <a:defRPr sz="1042" b="1"/>
            </a:lvl3pPr>
            <a:lvl4pPr marL="793882" indent="0">
              <a:buNone/>
              <a:defRPr sz="926" b="1"/>
            </a:lvl4pPr>
            <a:lvl5pPr marL="1058509" indent="0">
              <a:buNone/>
              <a:defRPr sz="926" b="1"/>
            </a:lvl5pPr>
            <a:lvl6pPr marL="1323137" indent="0">
              <a:buNone/>
              <a:defRPr sz="926" b="1"/>
            </a:lvl6pPr>
            <a:lvl7pPr marL="1587764" indent="0">
              <a:buNone/>
              <a:defRPr sz="926" b="1"/>
            </a:lvl7pPr>
            <a:lvl8pPr marL="1852392" indent="0">
              <a:buNone/>
              <a:defRPr sz="926" b="1"/>
            </a:lvl8pPr>
            <a:lvl9pPr marL="2117019" indent="0">
              <a:buNone/>
              <a:defRPr sz="92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565" y="3090173"/>
            <a:ext cx="2239070" cy="45451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79443" y="2073824"/>
            <a:ext cx="2250097" cy="1016349"/>
          </a:xfrm>
        </p:spPr>
        <p:txBody>
          <a:bodyPr anchor="b"/>
          <a:lstStyle>
            <a:lvl1pPr marL="0" indent="0">
              <a:buNone/>
              <a:defRPr sz="1389" b="1"/>
            </a:lvl1pPr>
            <a:lvl2pPr marL="264627" indent="0">
              <a:buNone/>
              <a:defRPr sz="1158" b="1"/>
            </a:lvl2pPr>
            <a:lvl3pPr marL="529255" indent="0">
              <a:buNone/>
              <a:defRPr sz="1042" b="1"/>
            </a:lvl3pPr>
            <a:lvl4pPr marL="793882" indent="0">
              <a:buNone/>
              <a:defRPr sz="926" b="1"/>
            </a:lvl4pPr>
            <a:lvl5pPr marL="1058509" indent="0">
              <a:buNone/>
              <a:defRPr sz="926" b="1"/>
            </a:lvl5pPr>
            <a:lvl6pPr marL="1323137" indent="0">
              <a:buNone/>
              <a:defRPr sz="926" b="1"/>
            </a:lvl6pPr>
            <a:lvl7pPr marL="1587764" indent="0">
              <a:buNone/>
              <a:defRPr sz="926" b="1"/>
            </a:lvl7pPr>
            <a:lvl8pPr marL="1852392" indent="0">
              <a:buNone/>
              <a:defRPr sz="926" b="1"/>
            </a:lvl8pPr>
            <a:lvl9pPr marL="2117019" indent="0">
              <a:buNone/>
              <a:defRPr sz="92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79443" y="3090173"/>
            <a:ext cx="2250097" cy="45451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7035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06592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6238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564" y="563986"/>
            <a:ext cx="1707042" cy="1973951"/>
          </a:xfrm>
        </p:spPr>
        <p:txBody>
          <a:bodyPr anchor="b"/>
          <a:lstStyle>
            <a:lvl1pPr>
              <a:defRPr sz="18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50098" y="1218054"/>
            <a:ext cx="2679442" cy="6011933"/>
          </a:xfrm>
        </p:spPr>
        <p:txBody>
          <a:bodyPr/>
          <a:lstStyle>
            <a:lvl1pPr>
              <a:defRPr sz="1852"/>
            </a:lvl1pPr>
            <a:lvl2pPr>
              <a:defRPr sz="1621"/>
            </a:lvl2pPr>
            <a:lvl3pPr>
              <a:defRPr sz="1389"/>
            </a:lvl3pPr>
            <a:lvl4pPr>
              <a:defRPr sz="1158"/>
            </a:lvl4pPr>
            <a:lvl5pPr>
              <a:defRPr sz="1158"/>
            </a:lvl5pPr>
            <a:lvl6pPr>
              <a:defRPr sz="1158"/>
            </a:lvl6pPr>
            <a:lvl7pPr>
              <a:defRPr sz="1158"/>
            </a:lvl7pPr>
            <a:lvl8pPr>
              <a:defRPr sz="1158"/>
            </a:lvl8pPr>
            <a:lvl9pPr>
              <a:defRPr sz="115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4564" y="2537936"/>
            <a:ext cx="1707042" cy="4701841"/>
          </a:xfrm>
        </p:spPr>
        <p:txBody>
          <a:bodyPr/>
          <a:lstStyle>
            <a:lvl1pPr marL="0" indent="0">
              <a:buNone/>
              <a:defRPr sz="926"/>
            </a:lvl1pPr>
            <a:lvl2pPr marL="264627" indent="0">
              <a:buNone/>
              <a:defRPr sz="810"/>
            </a:lvl2pPr>
            <a:lvl3pPr marL="529255" indent="0">
              <a:buNone/>
              <a:defRPr sz="695"/>
            </a:lvl3pPr>
            <a:lvl4pPr marL="793882" indent="0">
              <a:buNone/>
              <a:defRPr sz="579"/>
            </a:lvl4pPr>
            <a:lvl5pPr marL="1058509" indent="0">
              <a:buNone/>
              <a:defRPr sz="579"/>
            </a:lvl5pPr>
            <a:lvl6pPr marL="1323137" indent="0">
              <a:buNone/>
              <a:defRPr sz="579"/>
            </a:lvl6pPr>
            <a:lvl7pPr marL="1587764" indent="0">
              <a:buNone/>
              <a:defRPr sz="579"/>
            </a:lvl7pPr>
            <a:lvl8pPr marL="1852392" indent="0">
              <a:buNone/>
              <a:defRPr sz="579"/>
            </a:lvl8pPr>
            <a:lvl9pPr marL="2117019" indent="0">
              <a:buNone/>
              <a:defRPr sz="57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87047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564" y="563986"/>
            <a:ext cx="1707042" cy="1973951"/>
          </a:xfrm>
        </p:spPr>
        <p:txBody>
          <a:bodyPr anchor="b"/>
          <a:lstStyle>
            <a:lvl1pPr>
              <a:defRPr sz="18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50098" y="1218054"/>
            <a:ext cx="2679442" cy="6011933"/>
          </a:xfrm>
        </p:spPr>
        <p:txBody>
          <a:bodyPr anchor="t"/>
          <a:lstStyle>
            <a:lvl1pPr marL="0" indent="0">
              <a:buNone/>
              <a:defRPr sz="1852"/>
            </a:lvl1pPr>
            <a:lvl2pPr marL="264627" indent="0">
              <a:buNone/>
              <a:defRPr sz="1621"/>
            </a:lvl2pPr>
            <a:lvl3pPr marL="529255" indent="0">
              <a:buNone/>
              <a:defRPr sz="1389"/>
            </a:lvl3pPr>
            <a:lvl4pPr marL="793882" indent="0">
              <a:buNone/>
              <a:defRPr sz="1158"/>
            </a:lvl4pPr>
            <a:lvl5pPr marL="1058509" indent="0">
              <a:buNone/>
              <a:defRPr sz="1158"/>
            </a:lvl5pPr>
            <a:lvl6pPr marL="1323137" indent="0">
              <a:buNone/>
              <a:defRPr sz="1158"/>
            </a:lvl6pPr>
            <a:lvl7pPr marL="1587764" indent="0">
              <a:buNone/>
              <a:defRPr sz="1158"/>
            </a:lvl7pPr>
            <a:lvl8pPr marL="1852392" indent="0">
              <a:buNone/>
              <a:defRPr sz="1158"/>
            </a:lvl8pPr>
            <a:lvl9pPr marL="2117019" indent="0">
              <a:buNone/>
              <a:defRPr sz="115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4564" y="2537936"/>
            <a:ext cx="1707042" cy="4701841"/>
          </a:xfrm>
        </p:spPr>
        <p:txBody>
          <a:bodyPr/>
          <a:lstStyle>
            <a:lvl1pPr marL="0" indent="0">
              <a:buNone/>
              <a:defRPr sz="926"/>
            </a:lvl1pPr>
            <a:lvl2pPr marL="264627" indent="0">
              <a:buNone/>
              <a:defRPr sz="810"/>
            </a:lvl2pPr>
            <a:lvl3pPr marL="529255" indent="0">
              <a:buNone/>
              <a:defRPr sz="695"/>
            </a:lvl3pPr>
            <a:lvl4pPr marL="793882" indent="0">
              <a:buNone/>
              <a:defRPr sz="579"/>
            </a:lvl4pPr>
            <a:lvl5pPr marL="1058509" indent="0">
              <a:buNone/>
              <a:defRPr sz="579"/>
            </a:lvl5pPr>
            <a:lvl6pPr marL="1323137" indent="0">
              <a:buNone/>
              <a:defRPr sz="579"/>
            </a:lvl6pPr>
            <a:lvl7pPr marL="1587764" indent="0">
              <a:buNone/>
              <a:defRPr sz="579"/>
            </a:lvl7pPr>
            <a:lvl8pPr marL="1852392" indent="0">
              <a:buNone/>
              <a:defRPr sz="579"/>
            </a:lvl8pPr>
            <a:lvl9pPr marL="2117019" indent="0">
              <a:buNone/>
              <a:defRPr sz="57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17476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3875" y="450407"/>
            <a:ext cx="4564975" cy="1635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3875" y="2252027"/>
            <a:ext cx="4564975" cy="536765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3875" y="7840972"/>
            <a:ext cx="1190863" cy="4504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41CED-15DB-4AB5-BB22-AA2929B8408F}" type="datetimeFigureOut">
              <a:rPr lang="sv-SE" smtClean="0"/>
              <a:t>2020-0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53215" y="7840972"/>
            <a:ext cx="1786295" cy="4504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37987" y="7840972"/>
            <a:ext cx="1190863" cy="4504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528E0-F92B-4630-BF85-495995DABDB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83837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29255" rtl="0" eaLnBrk="1" latinLnBrk="0" hangingPunct="1">
        <a:lnSpc>
          <a:spcPct val="90000"/>
        </a:lnSpc>
        <a:spcBef>
          <a:spcPct val="0"/>
        </a:spcBef>
        <a:buNone/>
        <a:defRPr sz="25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2314" indent="-132314" algn="l" defTabSz="529255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1621" kern="1200">
          <a:solidFill>
            <a:schemeClr val="tx1"/>
          </a:solidFill>
          <a:latin typeface="+mn-lt"/>
          <a:ea typeface="+mn-ea"/>
          <a:cs typeface="+mn-cs"/>
        </a:defRPr>
      </a:lvl1pPr>
      <a:lvl2pPr marL="396941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389" kern="1200">
          <a:solidFill>
            <a:schemeClr val="tx1"/>
          </a:solidFill>
          <a:latin typeface="+mn-lt"/>
          <a:ea typeface="+mn-ea"/>
          <a:cs typeface="+mn-cs"/>
        </a:defRPr>
      </a:lvl2pPr>
      <a:lvl3pPr marL="661568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158" kern="1200">
          <a:solidFill>
            <a:schemeClr val="tx1"/>
          </a:solidFill>
          <a:latin typeface="+mn-lt"/>
          <a:ea typeface="+mn-ea"/>
          <a:cs typeface="+mn-cs"/>
        </a:defRPr>
      </a:lvl3pPr>
      <a:lvl4pPr marL="926196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4pPr>
      <a:lvl5pPr marL="1190823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5pPr>
      <a:lvl6pPr marL="1455450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6pPr>
      <a:lvl7pPr marL="1720078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7pPr>
      <a:lvl8pPr marL="1984705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8pPr>
      <a:lvl9pPr marL="2249333" indent="-132314" algn="l" defTabSz="529255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1pPr>
      <a:lvl2pPr marL="264627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2pPr>
      <a:lvl3pPr marL="529255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3pPr>
      <a:lvl4pPr marL="793882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4pPr>
      <a:lvl5pPr marL="1058509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5pPr>
      <a:lvl6pPr marL="1323137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6pPr>
      <a:lvl7pPr marL="1587764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7pPr>
      <a:lvl8pPr marL="1852392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8pPr>
      <a:lvl9pPr marL="2117019" algn="l" defTabSz="529255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8.png"/><Relationship Id="rId7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9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0D1871C-74F8-4335-9304-8390F4E70888}"/>
              </a:ext>
            </a:extLst>
          </p:cNvPr>
          <p:cNvGrpSpPr/>
          <p:nvPr/>
        </p:nvGrpSpPr>
        <p:grpSpPr>
          <a:xfrm>
            <a:off x="42939" y="426644"/>
            <a:ext cx="5206846" cy="1502523"/>
            <a:chOff x="7707" y="1244405"/>
            <a:chExt cx="5206846" cy="1502523"/>
          </a:xfrm>
        </p:grpSpPr>
        <p:pic>
          <p:nvPicPr>
            <p:cNvPr id="3" name="Bildobjekt 38" descr="En bild som visar skärmbild&#10;&#10;Automatiskt genererad beskrivning">
              <a:extLst>
                <a:ext uri="{FF2B5EF4-FFF2-40B4-BE49-F238E27FC236}">
                  <a16:creationId xmlns:a16="http://schemas.microsoft.com/office/drawing/2014/main" id="{3D8FDB84-AE32-4A5F-8308-B3C36C4212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77716" y="1444461"/>
              <a:ext cx="1276350" cy="1276350"/>
            </a:xfrm>
            <a:prstGeom prst="rect">
              <a:avLst/>
            </a:prstGeom>
          </p:spPr>
        </p:pic>
        <p:pic>
          <p:nvPicPr>
            <p:cNvPr id="4" name="Bildobjekt 36">
              <a:extLst>
                <a:ext uri="{FF2B5EF4-FFF2-40B4-BE49-F238E27FC236}">
                  <a16:creationId xmlns:a16="http://schemas.microsoft.com/office/drawing/2014/main" id="{2B434D4B-ECC5-49E0-8324-E48DF91DB2A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8203" y="1470578"/>
              <a:ext cx="1276350" cy="1276350"/>
            </a:xfrm>
            <a:prstGeom prst="rect">
              <a:avLst/>
            </a:prstGeom>
          </p:spPr>
        </p:pic>
        <p:pic>
          <p:nvPicPr>
            <p:cNvPr id="5" name="Bildobjekt 32">
              <a:extLst>
                <a:ext uri="{FF2B5EF4-FFF2-40B4-BE49-F238E27FC236}">
                  <a16:creationId xmlns:a16="http://schemas.microsoft.com/office/drawing/2014/main" id="{16AE0FBD-0842-4780-B26D-91B74978236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5801" y="1444461"/>
              <a:ext cx="1276350" cy="1276350"/>
            </a:xfrm>
            <a:prstGeom prst="rect">
              <a:avLst/>
            </a:prstGeom>
          </p:spPr>
        </p:pic>
        <p:pic>
          <p:nvPicPr>
            <p:cNvPr id="6" name="Bildobjekt 30">
              <a:extLst>
                <a:ext uri="{FF2B5EF4-FFF2-40B4-BE49-F238E27FC236}">
                  <a16:creationId xmlns:a16="http://schemas.microsoft.com/office/drawing/2014/main" id="{EC59A2A0-ED80-4FEE-BEA2-E0A05DBC680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07" y="1444461"/>
              <a:ext cx="1276350" cy="1276350"/>
            </a:xfrm>
            <a:prstGeom prst="rect">
              <a:avLst/>
            </a:prstGeom>
          </p:spPr>
        </p:pic>
        <p:cxnSp>
          <p:nvCxnSpPr>
            <p:cNvPr id="7" name="Rak pilkoppling 23">
              <a:extLst>
                <a:ext uri="{FF2B5EF4-FFF2-40B4-BE49-F238E27FC236}">
                  <a16:creationId xmlns:a16="http://schemas.microsoft.com/office/drawing/2014/main" id="{81BD358B-1C32-4C57-BC3B-77DE432250CE}"/>
                </a:ext>
              </a:extLst>
            </p:cNvPr>
            <p:cNvCxnSpPr>
              <a:cxnSpLocks/>
            </p:cNvCxnSpPr>
            <p:nvPr/>
          </p:nvCxnSpPr>
          <p:spPr>
            <a:xfrm>
              <a:off x="1957797" y="2362856"/>
              <a:ext cx="792777" cy="0"/>
            </a:xfrm>
            <a:prstGeom prst="straightConnector1">
              <a:avLst/>
            </a:prstGeom>
            <a:ln>
              <a:solidFill>
                <a:srgbClr val="2012D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Rak pilkoppling 26">
              <a:extLst>
                <a:ext uri="{FF2B5EF4-FFF2-40B4-BE49-F238E27FC236}">
                  <a16:creationId xmlns:a16="http://schemas.microsoft.com/office/drawing/2014/main" id="{879E9D52-78A9-4D18-8C44-C852154C4877}"/>
                </a:ext>
              </a:extLst>
            </p:cNvPr>
            <p:cNvCxnSpPr>
              <a:cxnSpLocks/>
            </p:cNvCxnSpPr>
            <p:nvPr/>
          </p:nvCxnSpPr>
          <p:spPr>
            <a:xfrm>
              <a:off x="3234147" y="1726216"/>
              <a:ext cx="792777" cy="0"/>
            </a:xfrm>
            <a:prstGeom prst="straightConnector1">
              <a:avLst/>
            </a:prstGeom>
            <a:ln>
              <a:solidFill>
                <a:srgbClr val="2012D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Rak pilkoppling 27">
              <a:extLst>
                <a:ext uri="{FF2B5EF4-FFF2-40B4-BE49-F238E27FC236}">
                  <a16:creationId xmlns:a16="http://schemas.microsoft.com/office/drawing/2014/main" id="{7EB284F0-E758-40F0-87B4-52184C18F4BA}"/>
                </a:ext>
              </a:extLst>
            </p:cNvPr>
            <p:cNvCxnSpPr>
              <a:cxnSpLocks/>
            </p:cNvCxnSpPr>
            <p:nvPr/>
          </p:nvCxnSpPr>
          <p:spPr>
            <a:xfrm>
              <a:off x="1085184" y="1726216"/>
              <a:ext cx="485519" cy="0"/>
            </a:xfrm>
            <a:prstGeom prst="straightConnector1">
              <a:avLst/>
            </a:prstGeom>
            <a:ln>
              <a:solidFill>
                <a:srgbClr val="2012D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ruta 39">
              <a:extLst>
                <a:ext uri="{FF2B5EF4-FFF2-40B4-BE49-F238E27FC236}">
                  <a16:creationId xmlns:a16="http://schemas.microsoft.com/office/drawing/2014/main" id="{D98AB56E-C43A-49F4-821A-E40FE90F0932}"/>
                </a:ext>
              </a:extLst>
            </p:cNvPr>
            <p:cNvSpPr txBox="1"/>
            <p:nvPr/>
          </p:nvSpPr>
          <p:spPr>
            <a:xfrm>
              <a:off x="568964" y="1244406"/>
              <a:ext cx="5162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11" name="textruta 40">
              <a:extLst>
                <a:ext uri="{FF2B5EF4-FFF2-40B4-BE49-F238E27FC236}">
                  <a16:creationId xmlns:a16="http://schemas.microsoft.com/office/drawing/2014/main" id="{CF9C151B-F812-4A02-9298-75A08753195F}"/>
                </a:ext>
              </a:extLst>
            </p:cNvPr>
            <p:cNvSpPr txBox="1"/>
            <p:nvPr/>
          </p:nvSpPr>
          <p:spPr>
            <a:xfrm>
              <a:off x="1772214" y="1244406"/>
              <a:ext cx="5162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sp>
          <p:nvSpPr>
            <p:cNvPr id="12" name="textruta 41">
              <a:extLst>
                <a:ext uri="{FF2B5EF4-FFF2-40B4-BE49-F238E27FC236}">
                  <a16:creationId xmlns:a16="http://schemas.microsoft.com/office/drawing/2014/main" id="{EF5C9114-CE6C-494C-A48F-72CA5150D4C1}"/>
                </a:ext>
              </a:extLst>
            </p:cNvPr>
            <p:cNvSpPr txBox="1"/>
            <p:nvPr/>
          </p:nvSpPr>
          <p:spPr>
            <a:xfrm>
              <a:off x="2913781" y="1254206"/>
              <a:ext cx="886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</p:txBody>
        </p:sp>
        <p:sp>
          <p:nvSpPr>
            <p:cNvPr id="13" name="textruta 42">
              <a:extLst>
                <a:ext uri="{FF2B5EF4-FFF2-40B4-BE49-F238E27FC236}">
                  <a16:creationId xmlns:a16="http://schemas.microsoft.com/office/drawing/2014/main" id="{E66D0E01-B8EA-4F86-943A-08040CDBABDD}"/>
                </a:ext>
              </a:extLst>
            </p:cNvPr>
            <p:cNvSpPr txBox="1"/>
            <p:nvPr/>
          </p:nvSpPr>
          <p:spPr>
            <a:xfrm>
              <a:off x="4280529" y="1244405"/>
              <a:ext cx="886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 CD45</a:t>
              </a:r>
              <a:r>
                <a:rPr lang="sv-SE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F9070DA1-0EA8-4400-A377-1B9DEA960E51}"/>
              </a:ext>
            </a:extLst>
          </p:cNvPr>
          <p:cNvSpPr txBox="1"/>
          <p:nvPr/>
        </p:nvSpPr>
        <p:spPr>
          <a:xfrm>
            <a:off x="1668" y="6146782"/>
            <a:ext cx="529272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analyses after data acquisi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to obtain single, live CD45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for subsequent data analysi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tmap illustrating ArcSinh5-transformed median marker expression in CD45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clusters (n = 125) delineated by hierarchical exploration of the major cell lineages. At the overview level of the HSNE analysis, double-negative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overlapped with the area of influence for either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Thus, this small cell population was not defined as a major cell lineage and downstream analysis of double-negative cells was performed with both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Color bars indicate cell lineages and the dendrogram shows the hierarchical clustering of defined subsets. HSNE, hierarchical stochastic neighbor embedding; ILC, innate lymphoid cells; mDC, myeloid dendritic cells; Mo, monocytes; pDC, plasmacytoid dendritic cells. 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D07592D-FCEB-41A0-A514-B459C7B282F8}"/>
              </a:ext>
            </a:extLst>
          </p:cNvPr>
          <p:cNvSpPr txBox="1"/>
          <p:nvPr/>
        </p:nvSpPr>
        <p:spPr>
          <a:xfrm>
            <a:off x="10160" y="57312"/>
            <a:ext cx="426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2BAD66-B716-46DE-B814-AF52FA3D3E26}"/>
              </a:ext>
            </a:extLst>
          </p:cNvPr>
          <p:cNvSpPr txBox="1"/>
          <p:nvPr/>
        </p:nvSpPr>
        <p:spPr>
          <a:xfrm>
            <a:off x="0" y="2121637"/>
            <a:ext cx="426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E1917DDE-F429-4699-8B1D-6BE73D16247B}"/>
              </a:ext>
            </a:extLst>
          </p:cNvPr>
          <p:cNvGrpSpPr/>
          <p:nvPr/>
        </p:nvGrpSpPr>
        <p:grpSpPr>
          <a:xfrm>
            <a:off x="10160" y="2547490"/>
            <a:ext cx="5304666" cy="3436102"/>
            <a:chOff x="-8766" y="3085116"/>
            <a:chExt cx="5304666" cy="3436102"/>
          </a:xfrm>
        </p:grpSpPr>
        <p:pic>
          <p:nvPicPr>
            <p:cNvPr id="35" name="Picture 34" descr="A picture containing food&#10;&#10;Description automatically generated">
              <a:extLst>
                <a:ext uri="{FF2B5EF4-FFF2-40B4-BE49-F238E27FC236}">
                  <a16:creationId xmlns:a16="http://schemas.microsoft.com/office/drawing/2014/main" id="{D8BBA3F6-21F8-4DAA-BDF2-E69620BF620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8766" y="3085116"/>
              <a:ext cx="5220000" cy="3436102"/>
            </a:xfrm>
            <a:prstGeom prst="rect">
              <a:avLst/>
            </a:prstGeom>
          </p:spPr>
        </p:pic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5B8AD4BE-6770-45CC-8445-9D40987200A7}"/>
                </a:ext>
              </a:extLst>
            </p:cNvPr>
            <p:cNvGrpSpPr/>
            <p:nvPr/>
          </p:nvGrpSpPr>
          <p:grpSpPr>
            <a:xfrm>
              <a:off x="4853325" y="3737999"/>
              <a:ext cx="442575" cy="2619583"/>
              <a:chOff x="4853325" y="3372239"/>
              <a:chExt cx="442575" cy="2619583"/>
            </a:xfrm>
          </p:grpSpPr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3FB6D8E1-31AD-4373-8C15-CFD5BD0CED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4721" y="3372239"/>
                <a:ext cx="0" cy="565200"/>
              </a:xfrm>
              <a:prstGeom prst="line">
                <a:avLst/>
              </a:prstGeom>
              <a:ln w="28575">
                <a:solidFill>
                  <a:srgbClr val="20E8B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3FCA8DC0-8F45-4B35-8F9E-29070EB4EB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4721" y="3961199"/>
                <a:ext cx="0" cy="169476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0B8ABB2F-A200-40CE-A4CD-0AD6C229F34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6360" y="4155311"/>
                <a:ext cx="1536" cy="601200"/>
              </a:xfrm>
              <a:prstGeom prst="line">
                <a:avLst/>
              </a:prstGeom>
              <a:ln w="28575">
                <a:solidFill>
                  <a:schemeClr val="accent4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926D68AB-F635-4B67-BD2F-AAA408D678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7948" y="4783643"/>
                <a:ext cx="0" cy="429707"/>
              </a:xfrm>
              <a:prstGeom prst="line">
                <a:avLst/>
              </a:prstGeom>
              <a:ln w="28575">
                <a:solidFill>
                  <a:srgbClr val="48E5F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26CFEBBF-1534-457F-A439-36A13921E1B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896360" y="5234516"/>
                <a:ext cx="1920" cy="306000"/>
              </a:xfrm>
              <a:prstGeom prst="line">
                <a:avLst/>
              </a:prstGeom>
              <a:ln w="28575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F638126B-5D0D-440B-AC21-9AE83DC822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6360" y="5564745"/>
                <a:ext cx="0" cy="183593"/>
              </a:xfrm>
              <a:prstGeom prst="line">
                <a:avLst/>
              </a:prstGeom>
              <a:ln w="28575">
                <a:solidFill>
                  <a:srgbClr val="DE3B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5EA22084-9CEB-411E-B489-552C781BE7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6870" y="5767388"/>
                <a:ext cx="0" cy="86400"/>
              </a:xfrm>
              <a:prstGeom prst="line">
                <a:avLst/>
              </a:prstGeom>
              <a:ln w="28575">
                <a:solidFill>
                  <a:srgbClr val="ED7BD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4D4D9DED-4EB9-4FD1-A1FE-837441373B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6360" y="5868990"/>
                <a:ext cx="0" cy="66927"/>
              </a:xfrm>
              <a:prstGeom prst="line">
                <a:avLst/>
              </a:prstGeom>
              <a:ln w="28575">
                <a:solidFill>
                  <a:srgbClr val="DA7BE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ruta 64">
                <a:extLst>
                  <a:ext uri="{FF2B5EF4-FFF2-40B4-BE49-F238E27FC236}">
                    <a16:creationId xmlns:a16="http://schemas.microsoft.com/office/drawing/2014/main" id="{27CF9EAD-8933-444B-9964-DCEE0E82BFE9}"/>
                  </a:ext>
                </a:extLst>
              </p:cNvPr>
              <p:cNvSpPr txBox="1"/>
              <p:nvPr/>
            </p:nvSpPr>
            <p:spPr>
              <a:xfrm>
                <a:off x="4853325" y="3556992"/>
                <a:ext cx="4394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r>
                  <a:rPr lang="sv-SE" sz="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</a:p>
            </p:txBody>
          </p:sp>
          <p:sp>
            <p:nvSpPr>
              <p:cNvPr id="28" name="textruta 64">
                <a:extLst>
                  <a:ext uri="{FF2B5EF4-FFF2-40B4-BE49-F238E27FC236}">
                    <a16:creationId xmlns:a16="http://schemas.microsoft.com/office/drawing/2014/main" id="{0EF621CE-AF28-4306-965F-125B180F1844}"/>
                  </a:ext>
                </a:extLst>
              </p:cNvPr>
              <p:cNvSpPr txBox="1"/>
              <p:nvPr/>
            </p:nvSpPr>
            <p:spPr>
              <a:xfrm>
                <a:off x="4856382" y="3955116"/>
                <a:ext cx="3486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Treg</a:t>
                </a:r>
              </a:p>
            </p:txBody>
          </p:sp>
          <p:sp>
            <p:nvSpPr>
              <p:cNvPr id="29" name="textruta 64">
                <a:extLst>
                  <a:ext uri="{FF2B5EF4-FFF2-40B4-BE49-F238E27FC236}">
                    <a16:creationId xmlns:a16="http://schemas.microsoft.com/office/drawing/2014/main" id="{347EEE6A-7B45-4FD3-B7AC-927625075AF8}"/>
                  </a:ext>
                </a:extLst>
              </p:cNvPr>
              <p:cNvSpPr txBox="1"/>
              <p:nvPr/>
            </p:nvSpPr>
            <p:spPr>
              <a:xfrm>
                <a:off x="4859675" y="4357816"/>
                <a:ext cx="43622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  <a:r>
                  <a:rPr lang="sv-SE" sz="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</a:p>
            </p:txBody>
          </p:sp>
          <p:sp>
            <p:nvSpPr>
              <p:cNvPr id="30" name="textruta 64">
                <a:extLst>
                  <a:ext uri="{FF2B5EF4-FFF2-40B4-BE49-F238E27FC236}">
                    <a16:creationId xmlns:a16="http://schemas.microsoft.com/office/drawing/2014/main" id="{161432C3-6944-4BE1-BA84-699B758401BF}"/>
                  </a:ext>
                </a:extLst>
              </p:cNvPr>
              <p:cNvSpPr txBox="1"/>
              <p:nvPr/>
            </p:nvSpPr>
            <p:spPr>
              <a:xfrm>
                <a:off x="4860257" y="4915311"/>
                <a:ext cx="267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1" name="textruta 64">
                <a:extLst>
                  <a:ext uri="{FF2B5EF4-FFF2-40B4-BE49-F238E27FC236}">
                    <a16:creationId xmlns:a16="http://schemas.microsoft.com/office/drawing/2014/main" id="{CB4610A4-E56B-4E26-B00E-5E16726755BD}"/>
                  </a:ext>
                </a:extLst>
              </p:cNvPr>
              <p:cNvSpPr txBox="1"/>
              <p:nvPr/>
            </p:nvSpPr>
            <p:spPr>
              <a:xfrm>
                <a:off x="4853773" y="5250934"/>
                <a:ext cx="3374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K</a:t>
                </a:r>
              </a:p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ILC</a:t>
                </a:r>
              </a:p>
            </p:txBody>
          </p:sp>
          <p:sp>
            <p:nvSpPr>
              <p:cNvPr id="32" name="textruta 64">
                <a:extLst>
                  <a:ext uri="{FF2B5EF4-FFF2-40B4-BE49-F238E27FC236}">
                    <a16:creationId xmlns:a16="http://schemas.microsoft.com/office/drawing/2014/main" id="{4DF082E0-ABA1-46C3-ADB5-7ACA6A84496D}"/>
                  </a:ext>
                </a:extLst>
              </p:cNvPr>
              <p:cNvSpPr txBox="1"/>
              <p:nvPr/>
            </p:nvSpPr>
            <p:spPr>
              <a:xfrm>
                <a:off x="4855323" y="5568530"/>
                <a:ext cx="29511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Mo</a:t>
                </a:r>
              </a:p>
            </p:txBody>
          </p:sp>
          <p:sp>
            <p:nvSpPr>
              <p:cNvPr id="33" name="textruta 64">
                <a:extLst>
                  <a:ext uri="{FF2B5EF4-FFF2-40B4-BE49-F238E27FC236}">
                    <a16:creationId xmlns:a16="http://schemas.microsoft.com/office/drawing/2014/main" id="{C7D75148-A6EA-4E85-B00C-FD8DFECDDCF0}"/>
                  </a:ext>
                </a:extLst>
              </p:cNvPr>
              <p:cNvSpPr txBox="1"/>
              <p:nvPr/>
            </p:nvSpPr>
            <p:spPr>
              <a:xfrm>
                <a:off x="4862850" y="5714109"/>
                <a:ext cx="37801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mDC</a:t>
                </a:r>
              </a:p>
            </p:txBody>
          </p:sp>
          <p:sp>
            <p:nvSpPr>
              <p:cNvPr id="34" name="textruta 64">
                <a:extLst>
                  <a:ext uri="{FF2B5EF4-FFF2-40B4-BE49-F238E27FC236}">
                    <a16:creationId xmlns:a16="http://schemas.microsoft.com/office/drawing/2014/main" id="{4632884C-0D26-4F81-B353-2CAFEFCFB899}"/>
                  </a:ext>
                </a:extLst>
              </p:cNvPr>
              <p:cNvSpPr txBox="1"/>
              <p:nvPr/>
            </p:nvSpPr>
            <p:spPr>
              <a:xfrm>
                <a:off x="4856500" y="5807156"/>
                <a:ext cx="37801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pDC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10276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keyboard&#10;&#10;Description automatically generated">
            <a:extLst>
              <a:ext uri="{FF2B5EF4-FFF2-40B4-BE49-F238E27FC236}">
                <a16:creationId xmlns:a16="http://schemas.microsoft.com/office/drawing/2014/main" id="{5E15852E-E165-4CAF-922E-964E233C07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252"/>
            <a:ext cx="5292725" cy="70582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F678F70-226A-4B6C-921A-E4A6C25A1A59}"/>
              </a:ext>
            </a:extLst>
          </p:cNvPr>
          <p:cNvSpPr txBox="1"/>
          <p:nvPr/>
        </p:nvSpPr>
        <p:spPr>
          <a:xfrm>
            <a:off x="7460" y="6854097"/>
            <a:ext cx="528526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cation of CD45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Eight major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lineages were stratified after performing collective dimensionality reduction and clustering analyses. CD8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4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lineages were divided into naïve and memory populations. Density maps contain cells from healthy controls (HC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5) and patients with new-onset (N-T1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) and long-standing (L-T1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9) type 1 diabetes, Hashimoto’s thyroiditis (HT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, Graves’ disease (G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) and autoimmune Addison’s disease (A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. ILC, innate lymphoid cells; mDC, myeloid dendritic cells; Mo, monocytes; pDC, plasmacytoid dendritic cells.   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03965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 descr="A close up of a flower&#10;&#10;Description automatically generated">
            <a:extLst>
              <a:ext uri="{FF2B5EF4-FFF2-40B4-BE49-F238E27FC236}">
                <a16:creationId xmlns:a16="http://schemas.microsoft.com/office/drawing/2014/main" id="{4AF30E8A-15C1-432C-A5E2-E0CA9528D3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8961" y="1448068"/>
            <a:ext cx="900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 descr="A close up of a flower&#10;&#10;Description automatically generated">
            <a:extLst>
              <a:ext uri="{FF2B5EF4-FFF2-40B4-BE49-F238E27FC236}">
                <a16:creationId xmlns:a16="http://schemas.microsoft.com/office/drawing/2014/main" id="{19E4F35D-E83E-489A-93DA-C6FED68B43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7256" y="1446268"/>
            <a:ext cx="900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F7AF3CFC-87A3-465D-86B8-788BD9567D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1532853"/>
              </p:ext>
            </p:extLst>
          </p:nvPr>
        </p:nvGraphicFramePr>
        <p:xfrm>
          <a:off x="1196751" y="3125555"/>
          <a:ext cx="2520950" cy="3449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Prism 8" r:id="rId5" imgW="2562726" imgH="3512943" progId="Prism8.Document">
                  <p:embed/>
                </p:oleObj>
              </mc:Choice>
              <mc:Fallback>
                <p:oleObj name="Prism 8" r:id="rId5" imgW="2562726" imgH="3512943" progId="Prism8.Document">
                  <p:embed/>
                  <p:pic>
                    <p:nvPicPr>
                      <p:cNvPr id="54" name="Objekt 3">
                        <a:extLst>
                          <a:ext uri="{FF2B5EF4-FFF2-40B4-BE49-F238E27FC236}">
                            <a16:creationId xmlns:a16="http://schemas.microsoft.com/office/drawing/2014/main" id="{CA0CD233-9B72-4A7E-908C-50829B5C93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96751" y="3125555"/>
                        <a:ext cx="2520950" cy="3449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6F58A3D-3281-4BA9-994A-0FEC2C86B58D}"/>
              </a:ext>
            </a:extLst>
          </p:cNvPr>
          <p:cNvSpPr txBox="1"/>
          <p:nvPr/>
        </p:nvSpPr>
        <p:spPr>
          <a:xfrm>
            <a:off x="0" y="6838986"/>
            <a:ext cx="529272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expressing T-bet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NE-embedding of CD19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showing the relative expression of markers defining cluster #12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requency of CD11c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healthy controls (HC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5) and patients with new-onset (N-T1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) and long-standing (L-T1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9) type 1 diabetes, Hashimoto’s thyroiditis (HT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, Graves’ disease (G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) and autoimmune Addison’s disease (AD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. Each dot represents an individual sample and bars indicate median. One-way ANOVA with Tukey’s test for multiple compariso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NE, hierarchical stochastic neighbor embedding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5DF69517-681C-48B7-BAA8-6195ED63D19B}"/>
              </a:ext>
            </a:extLst>
          </p:cNvPr>
          <p:cNvGrpSpPr/>
          <p:nvPr/>
        </p:nvGrpSpPr>
        <p:grpSpPr>
          <a:xfrm>
            <a:off x="646697" y="1267290"/>
            <a:ext cx="3999330" cy="1339373"/>
            <a:chOff x="376913" y="3714047"/>
            <a:chExt cx="3999330" cy="1339373"/>
          </a:xfrm>
        </p:grpSpPr>
        <p:cxnSp>
          <p:nvCxnSpPr>
            <p:cNvPr id="7" name="Rak pilkoppling 72">
              <a:extLst>
                <a:ext uri="{FF2B5EF4-FFF2-40B4-BE49-F238E27FC236}">
                  <a16:creationId xmlns:a16="http://schemas.microsoft.com/office/drawing/2014/main" id="{EB34D501-A1DC-4519-9543-B095F56064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2356" y="3777614"/>
              <a:ext cx="0" cy="106512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Rak pilkoppling 73">
              <a:extLst>
                <a:ext uri="{FF2B5EF4-FFF2-40B4-BE49-F238E27FC236}">
                  <a16:creationId xmlns:a16="http://schemas.microsoft.com/office/drawing/2014/main" id="{C46AB3EE-078A-4F2B-AE2E-7288E4696AE4}"/>
                </a:ext>
              </a:extLst>
            </p:cNvPr>
            <p:cNvCxnSpPr>
              <a:cxnSpLocks/>
            </p:cNvCxnSpPr>
            <p:nvPr/>
          </p:nvCxnSpPr>
          <p:spPr>
            <a:xfrm>
              <a:off x="595858" y="4837976"/>
              <a:ext cx="378038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ruta 74">
              <a:extLst>
                <a:ext uri="{FF2B5EF4-FFF2-40B4-BE49-F238E27FC236}">
                  <a16:creationId xmlns:a16="http://schemas.microsoft.com/office/drawing/2014/main" id="{CD80EF6C-96E6-45B3-AC69-2E3176799FE1}"/>
                </a:ext>
              </a:extLst>
            </p:cNvPr>
            <p:cNvSpPr txBox="1"/>
            <p:nvPr/>
          </p:nvSpPr>
          <p:spPr>
            <a:xfrm>
              <a:off x="2173277" y="4837976"/>
              <a:ext cx="5499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800" dirty="0">
                  <a:latin typeface="Arial" panose="020B0604020202020204" pitchFamily="34" charset="0"/>
                  <a:cs typeface="Arial" panose="020B0604020202020204" pitchFamily="34" charset="0"/>
                </a:rPr>
                <a:t>HSNE1</a:t>
              </a:r>
            </a:p>
          </p:txBody>
        </p:sp>
        <p:sp>
          <p:nvSpPr>
            <p:cNvPr id="10" name="textruta 75">
              <a:extLst>
                <a:ext uri="{FF2B5EF4-FFF2-40B4-BE49-F238E27FC236}">
                  <a16:creationId xmlns:a16="http://schemas.microsoft.com/office/drawing/2014/main" id="{954C4751-7ABF-4ED1-A763-84C4F9E71512}"/>
                </a:ext>
              </a:extLst>
            </p:cNvPr>
            <p:cNvSpPr txBox="1"/>
            <p:nvPr/>
          </p:nvSpPr>
          <p:spPr>
            <a:xfrm rot="16200000">
              <a:off x="195306" y="4236466"/>
              <a:ext cx="578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800" dirty="0">
                  <a:latin typeface="Arial" panose="020B0604020202020204" pitchFamily="34" charset="0"/>
                  <a:cs typeface="Arial" panose="020B0604020202020204" pitchFamily="34" charset="0"/>
                </a:rPr>
                <a:t>HSNE2</a:t>
              </a:r>
            </a:p>
          </p:txBody>
        </p:sp>
        <p:grpSp>
          <p:nvGrpSpPr>
            <p:cNvPr id="11" name="Grupo 63">
              <a:extLst>
                <a:ext uri="{FF2B5EF4-FFF2-40B4-BE49-F238E27FC236}">
                  <a16:creationId xmlns:a16="http://schemas.microsoft.com/office/drawing/2014/main" id="{A20E30DF-CA22-4B37-844B-54AF43F70D5D}"/>
                </a:ext>
              </a:extLst>
            </p:cNvPr>
            <p:cNvGrpSpPr/>
            <p:nvPr/>
          </p:nvGrpSpPr>
          <p:grpSpPr>
            <a:xfrm>
              <a:off x="1788636" y="3714047"/>
              <a:ext cx="1349954" cy="184688"/>
              <a:chOff x="2076356" y="3399305"/>
              <a:chExt cx="1349954" cy="184688"/>
            </a:xfrm>
          </p:grpSpPr>
          <p:pic>
            <p:nvPicPr>
              <p:cNvPr id="20" name="Bildobjekt 102">
                <a:extLst>
                  <a:ext uri="{FF2B5EF4-FFF2-40B4-BE49-F238E27FC236}">
                    <a16:creationId xmlns:a16="http://schemas.microsoft.com/office/drawing/2014/main" id="{DE00B2A1-3476-4C17-82F5-9A3E607379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2717888" y="3069682"/>
                <a:ext cx="45719" cy="873953"/>
              </a:xfrm>
              <a:prstGeom prst="rect">
                <a:avLst/>
              </a:prstGeom>
            </p:spPr>
          </p:pic>
          <p:sp>
            <p:nvSpPr>
              <p:cNvPr id="21" name="textruta 103">
                <a:extLst>
                  <a:ext uri="{FF2B5EF4-FFF2-40B4-BE49-F238E27FC236}">
                    <a16:creationId xmlns:a16="http://schemas.microsoft.com/office/drawing/2014/main" id="{3A8529CB-75C3-43AB-BDD8-75676413AF8E}"/>
                  </a:ext>
                </a:extLst>
              </p:cNvPr>
              <p:cNvSpPr txBox="1"/>
              <p:nvPr/>
            </p:nvSpPr>
            <p:spPr>
              <a:xfrm>
                <a:off x="2076356" y="3399327"/>
                <a:ext cx="29878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22" name="textruta 104">
                <a:extLst>
                  <a:ext uri="{FF2B5EF4-FFF2-40B4-BE49-F238E27FC236}">
                    <a16:creationId xmlns:a16="http://schemas.microsoft.com/office/drawing/2014/main" id="{E7EB8E71-1301-4F2A-A02F-D4F1FBA9C206}"/>
                  </a:ext>
                </a:extLst>
              </p:cNvPr>
              <p:cNvSpPr txBox="1"/>
              <p:nvPr/>
            </p:nvSpPr>
            <p:spPr>
              <a:xfrm>
                <a:off x="3083487" y="3399305"/>
                <a:ext cx="3428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3F6F5CE-DA7A-4BDF-8EE5-5A7950F0BAF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0446" y="3894250"/>
              <a:ext cx="900000" cy="90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ruta 5">
              <a:extLst>
                <a:ext uri="{FF2B5EF4-FFF2-40B4-BE49-F238E27FC236}">
                  <a16:creationId xmlns:a16="http://schemas.microsoft.com/office/drawing/2014/main" id="{BF5A492B-2F88-4FD8-BE55-5D9E91BBE768}"/>
                </a:ext>
              </a:extLst>
            </p:cNvPr>
            <p:cNvSpPr txBox="1"/>
            <p:nvPr/>
          </p:nvSpPr>
          <p:spPr>
            <a:xfrm>
              <a:off x="581180" y="3889135"/>
              <a:ext cx="45427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600" dirty="0">
                  <a:latin typeface="Arial" panose="020B0604020202020204" pitchFamily="34" charset="0"/>
                  <a:cs typeface="Arial" panose="020B0604020202020204" pitchFamily="34" charset="0"/>
                </a:rPr>
                <a:t>CD20</a:t>
              </a:r>
            </a:p>
          </p:txBody>
        </p:sp>
        <p:pic>
          <p:nvPicPr>
            <p:cNvPr id="14" name="Picture 13" descr="A close up of a flower&#10;&#10;Description automatically generated">
              <a:extLst>
                <a:ext uri="{FF2B5EF4-FFF2-40B4-BE49-F238E27FC236}">
                  <a16:creationId xmlns:a16="http://schemas.microsoft.com/office/drawing/2014/main" id="{349A64B1-0AD2-4706-B4F2-CEFCB208521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7683" y="3894189"/>
              <a:ext cx="900000" cy="90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" name="textruta 5">
              <a:extLst>
                <a:ext uri="{FF2B5EF4-FFF2-40B4-BE49-F238E27FC236}">
                  <a16:creationId xmlns:a16="http://schemas.microsoft.com/office/drawing/2014/main" id="{7414E0CA-3B81-428A-A9CB-CECC7B12302C}"/>
                </a:ext>
              </a:extLst>
            </p:cNvPr>
            <p:cNvSpPr txBox="1"/>
            <p:nvPr/>
          </p:nvSpPr>
          <p:spPr>
            <a:xfrm>
              <a:off x="1494998" y="3889135"/>
              <a:ext cx="4682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600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17" name="textruta 5">
              <a:extLst>
                <a:ext uri="{FF2B5EF4-FFF2-40B4-BE49-F238E27FC236}">
                  <a16:creationId xmlns:a16="http://schemas.microsoft.com/office/drawing/2014/main" id="{35DB2650-DA0D-4FA6-BD7B-EB38C8C55F61}"/>
                </a:ext>
              </a:extLst>
            </p:cNvPr>
            <p:cNvSpPr txBox="1"/>
            <p:nvPr/>
          </p:nvSpPr>
          <p:spPr>
            <a:xfrm>
              <a:off x="3311279" y="3888313"/>
              <a:ext cx="4141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600" dirty="0">
                  <a:latin typeface="Arial" panose="020B0604020202020204" pitchFamily="34" charset="0"/>
                  <a:cs typeface="Arial" panose="020B0604020202020204" pitchFamily="34" charset="0"/>
                </a:rPr>
                <a:t>Tbet</a:t>
              </a:r>
            </a:p>
          </p:txBody>
        </p:sp>
        <p:sp>
          <p:nvSpPr>
            <p:cNvPr id="19" name="textruta 5">
              <a:extLst>
                <a:ext uri="{FF2B5EF4-FFF2-40B4-BE49-F238E27FC236}">
                  <a16:creationId xmlns:a16="http://schemas.microsoft.com/office/drawing/2014/main" id="{E27A1157-09FC-45F3-847B-DE970ECDA858}"/>
                </a:ext>
              </a:extLst>
            </p:cNvPr>
            <p:cNvSpPr txBox="1"/>
            <p:nvPr/>
          </p:nvSpPr>
          <p:spPr>
            <a:xfrm>
              <a:off x="2390633" y="3899588"/>
              <a:ext cx="53170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600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</a:p>
          </p:txBody>
        </p:sp>
      </p:grpSp>
      <p:sp>
        <p:nvSpPr>
          <p:cNvPr id="23" name="textruta 103">
            <a:extLst>
              <a:ext uri="{FF2B5EF4-FFF2-40B4-BE49-F238E27FC236}">
                <a16:creationId xmlns:a16="http://schemas.microsoft.com/office/drawing/2014/main" id="{EC3C0177-20E4-4E9B-A153-78B6075AEAB9}"/>
              </a:ext>
            </a:extLst>
          </p:cNvPr>
          <p:cNvSpPr txBox="1"/>
          <p:nvPr/>
        </p:nvSpPr>
        <p:spPr>
          <a:xfrm>
            <a:off x="2278849" y="1169095"/>
            <a:ext cx="8999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600" dirty="0">
                <a:latin typeface="Arial" panose="020B0604020202020204" pitchFamily="34" charset="0"/>
                <a:cs typeface="Arial" panose="020B0604020202020204" pitchFamily="34" charset="0"/>
              </a:rPr>
              <a:t>Marker expressio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4A80E01-2302-47C1-B5F8-2A8EF94FD006}"/>
              </a:ext>
            </a:extLst>
          </p:cNvPr>
          <p:cNvSpPr txBox="1"/>
          <p:nvPr/>
        </p:nvSpPr>
        <p:spPr>
          <a:xfrm>
            <a:off x="10160" y="694301"/>
            <a:ext cx="426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8284929-5A82-41B9-AD54-DB196FE4E719}"/>
              </a:ext>
            </a:extLst>
          </p:cNvPr>
          <p:cNvSpPr txBox="1"/>
          <p:nvPr/>
        </p:nvSpPr>
        <p:spPr>
          <a:xfrm>
            <a:off x="0" y="2940889"/>
            <a:ext cx="426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004633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5D94542C-B044-44B8-84E0-98D6A22EF1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30955"/>
            <a:ext cx="5292725" cy="455124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3756765-CC80-4E07-B4C2-2853F87ACD92}"/>
              </a:ext>
            </a:extLst>
          </p:cNvPr>
          <p:cNvSpPr txBox="1"/>
          <p:nvPr/>
        </p:nvSpPr>
        <p:spPr>
          <a:xfrm>
            <a:off x="0" y="6140331"/>
            <a:ext cx="529272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al exploration of six cell lineages. Panels represent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ïve CD4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mory CD4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gs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ïve CD8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eloid and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acytoid dendritic cel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NE-embeddings depicting the local probability density of each cell type (upper left) and subsets defined by Gaussian mean-shift clustering (lower left). Heatmaps showing ArcSinh5-transformed median expression of markers within the clusters identified in each panel. The dendrograms depict hierarchical clustering of subsets. Double-negative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can be observed in both naïve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lineages. There were no differences in these clusters between healthy control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5) and patients with new-onse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) and long-standing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9) type 1 diabetes, Hashimoto’s thyroiditi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, Graves’ diseas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) and autoimmune Addison’s diseas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NE, hierarchical stochastic neighbor embedding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0966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08C48C2-8916-44F7-9180-995AE6BCFA9E}"/>
              </a:ext>
            </a:extLst>
          </p:cNvPr>
          <p:cNvSpPr txBox="1"/>
          <p:nvPr/>
        </p:nvSpPr>
        <p:spPr>
          <a:xfrm>
            <a:off x="0" y="6890128"/>
            <a:ext cx="529272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In-house mass cytometry panel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panel was designed to phenotypically characterize PBMC by including markers for lineage, activation/function, differentiation, cytokines, chemokine receptors and transcription factors. Thirty-two lanthanide-conjugated antibodies were divided between extra- (Extra) and intracellular (Intra) staining cocktails. Clones of the monoclonal antibodies are described. Monoclonal antibodies from Biolegend were conjugated with corresponding metal at the Flow Cytometry Unit, Linköping University (*)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7766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0DF36E3-CA54-4565-99AE-A6A16903EF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469902"/>
              </p:ext>
            </p:extLst>
          </p:nvPr>
        </p:nvGraphicFramePr>
        <p:xfrm>
          <a:off x="370522" y="532355"/>
          <a:ext cx="4551679" cy="7826586"/>
        </p:xfrm>
        <a:graphic>
          <a:graphicData uri="http://schemas.openxmlformats.org/drawingml/2006/table">
            <a:tbl>
              <a:tblPr firstRow="1" firstCol="1"/>
              <a:tblGrid>
                <a:gridCol w="991357">
                  <a:extLst>
                    <a:ext uri="{9D8B030D-6E8A-4147-A177-3AD203B41FA5}">
                      <a16:colId xmlns:a16="http://schemas.microsoft.com/office/drawing/2014/main" val="496163354"/>
                    </a:ext>
                  </a:extLst>
                </a:gridCol>
                <a:gridCol w="836598">
                  <a:extLst>
                    <a:ext uri="{9D8B030D-6E8A-4147-A177-3AD203B41FA5}">
                      <a16:colId xmlns:a16="http://schemas.microsoft.com/office/drawing/2014/main" val="3618546546"/>
                    </a:ext>
                  </a:extLst>
                </a:gridCol>
                <a:gridCol w="1030499">
                  <a:extLst>
                    <a:ext uri="{9D8B030D-6E8A-4147-A177-3AD203B41FA5}">
                      <a16:colId xmlns:a16="http://schemas.microsoft.com/office/drawing/2014/main" val="3627184910"/>
                    </a:ext>
                  </a:extLst>
                </a:gridCol>
                <a:gridCol w="842061">
                  <a:extLst>
                    <a:ext uri="{9D8B030D-6E8A-4147-A177-3AD203B41FA5}">
                      <a16:colId xmlns:a16="http://schemas.microsoft.com/office/drawing/2014/main" val="744794157"/>
                    </a:ext>
                  </a:extLst>
                </a:gridCol>
                <a:gridCol w="851164">
                  <a:extLst>
                    <a:ext uri="{9D8B030D-6E8A-4147-A177-3AD203B41FA5}">
                      <a16:colId xmlns:a16="http://schemas.microsoft.com/office/drawing/2014/main" val="232263497"/>
                    </a:ext>
                  </a:extLst>
                </a:gridCol>
              </a:tblGrid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anthanide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rke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one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pplie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ep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810238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2Pd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e 1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i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6085989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4Pd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e 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i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5280000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5Pd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e 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i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436307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6P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e 4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i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135529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8P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e 5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i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3927490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0P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e 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rcodi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434725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Y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5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3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9723088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1 P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R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34E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504555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2 N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9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B19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69642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4 N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4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P4-25D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6671762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5 N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A-T4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-stain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8906475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7 S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15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026833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8 N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G8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371051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9 S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25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A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3580997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0 N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8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A-T8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GB" sz="12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sv-SE" sz="1200" baseline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4713796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1 Eu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2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H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0704348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2 S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5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HCD5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GB" sz="12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14077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3 Eu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R4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541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451256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5 G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2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128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8963982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6 G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86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T2.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7127733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8 G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Q1-17H1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4796846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9 Tb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R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43H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082323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0 Gd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et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B1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038597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1 Dy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69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FN5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GB" sz="1200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8222037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2 Dy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XP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CH101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8025770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3 Dy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XCR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025H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8071533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4 Dy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17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49-65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4028624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5 Ho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5RO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CHL1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611819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6 E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-1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JES3-9D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801929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7 E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TA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WAJ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613580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8 E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Ng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2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1141575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9 T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5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10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941753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0 E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CHT1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6496914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1 Yb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20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H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412012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2 Yb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8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T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3897091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4 Yb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LA-D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243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8893577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5 Lu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4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5E2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8993234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6 Yb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27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019D5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r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4856353"/>
                  </a:ext>
                </a:extLst>
              </a:tr>
              <a:tr h="35799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1/193Ir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NA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inglet/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ublet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8734683"/>
                  </a:ext>
                </a:extLst>
              </a:tr>
              <a:tr h="1801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5Pt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uidigm</a:t>
                      </a:r>
                      <a:endParaRPr lang="sv-SE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ive/dead</a:t>
                      </a:r>
                      <a:endParaRPr lang="sv-SE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910" marR="4391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16430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68690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0</TotalTime>
  <Words>989</Words>
  <Application>Microsoft Office PowerPoint</Application>
  <PresentationFormat>Custom</PresentationFormat>
  <Paragraphs>23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uise Magnusson</dc:creator>
  <cp:lastModifiedBy>Louise Magnusson</cp:lastModifiedBy>
  <cp:revision>110</cp:revision>
  <dcterms:created xsi:type="dcterms:W3CDTF">2019-08-27T13:52:57Z</dcterms:created>
  <dcterms:modified xsi:type="dcterms:W3CDTF">2020-02-17T08:29:43Z</dcterms:modified>
</cp:coreProperties>
</file>